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80" y="2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FF896F-60B9-ECC2-F414-D0DAD4615A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52F1F2D-B034-ADCD-5C0C-7CEDCBBA0F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492A27-97D4-9991-447A-244980B4E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213C32-E6FA-E93A-37BA-9A5D7A679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AB372D-D047-545D-832C-ABF2CFBFC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169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418A9C-8237-2002-04D5-FEEE0DE37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C2FF97-08D3-BB74-31FE-4043A0459A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5F8D29-981C-B6EF-0498-3AE8A843C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CE0ECC-8AB4-58DD-AB76-B06E21ED4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8CEA36-BFCD-BE6F-F08E-01FF7B412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906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EF1169-1F8A-17B1-9AE4-A17133783C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EE4B3E-0626-87F6-F813-A8358AA443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B46130-61B4-38F0-6024-488BF07B3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C0AA25-42A4-54AF-8794-BCD20D3AC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B45E58-AED3-3D13-B954-579418125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636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6E353C-B854-EBA5-E24D-50BF71B04B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9FC6CD-687D-FE7D-1090-20AA0B524B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8B6F9C-46CB-1631-6871-4D9D3150A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BC6DE5-5083-E2A4-CEE0-681A05DE9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C3D1E6-0A39-980B-134B-36FD95149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232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08ACD7-FA83-0A16-CD5A-B6DF82F94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901588-83B9-6753-AF22-F02C58DE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4DE8BE-4A2D-3350-7640-44EF71605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5BC24F-868F-09E9-E554-02B7A4A74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7DE7C1-98C5-22F8-72DF-47F1B4197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8784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557C9E-A95C-5939-D6F4-695A187C1B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6BA025-18B1-04A7-CB00-10951E21CF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B4D5079-4874-176F-9DC3-5343B64585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60CAAB-5B15-7F2A-6DEE-0FEB956AD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7E2417-1346-1D63-8D6E-4F59D2913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F8835D-704C-4E69-141C-08A97A35E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36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CB1D0F-E3DE-FB91-0450-EB814461F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D99E1-D0B4-3D72-B72F-C37B37F78F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1B26A5-2475-DB15-EACB-870FF9ECE5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A57F542-D143-C055-9CC1-6AF30E50D3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68422AF-A166-5F70-499A-E862F3CF92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1FEF22B-0741-2DDB-89BF-A16D04625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01F0FA3-DF6A-4EC9-1869-F080C04C4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89EE00B-6702-2775-2ED6-797D34078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3756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2524C8-9AF6-8950-CD3D-9ED610788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0DC036A-FA5C-12ED-AFA1-02C139325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A43ADBA-6405-1658-F669-6BD4CA04C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92D52EA-836C-90CC-557E-A23EA8DB6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18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8E50EE1-12BE-8265-3664-5DA5AAC2E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4520773-3EF8-C919-7DC7-06693C73C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F68CB6E-8708-9820-5CE2-AA52C6423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37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72AD6A-BFC1-104A-4416-6933BA607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294C00B-B579-1BA4-2A12-3DE0EE4922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505D7E8-866B-DE67-DD84-51D1E14AA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5CE39AA-086B-5BC6-83A0-1208E673F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5721EB3-638C-F21A-053B-60D612469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E966602-8E8C-3CDE-0DCB-7A46F4D5E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9015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6966EC-300A-0426-9183-5ADCD418B0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27A1BFD-8F95-5EFB-1463-03C58FB541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FDAF6F7-17C1-E40A-98CB-411D0C411F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C043F0D-6170-B4EA-5AA2-4EF0F4F02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7C9B51F-1B7B-A93C-AC23-A73FF0CCF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5CBAF3-836A-E40F-E234-B8671FAA3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882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6893AB0-DEF7-706D-2F2F-1ECFEBA4F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3EB0F40-87AD-6452-7C7A-BFF1E73606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E0BEB1-D008-87ED-8E8E-87713426FD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CE4B6E-0E86-4186-B325-CA64A6AD3258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7D88D9-D044-5FD3-57DD-ADC1E78D1C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487F79-B2A7-AE9B-3978-EA5057FBF5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821681-958F-4ECE-8389-F63CC0785E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0297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7650BB5-8CE9-9F9F-E9EB-7ABBB045CB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3390155"/>
              </p:ext>
            </p:extLst>
          </p:nvPr>
        </p:nvGraphicFramePr>
        <p:xfrm>
          <a:off x="1872342" y="201384"/>
          <a:ext cx="8730348" cy="6455231"/>
        </p:xfrm>
        <a:graphic>
          <a:graphicData uri="http://schemas.openxmlformats.org/drawingml/2006/table">
            <a:tbl>
              <a:tblPr/>
              <a:tblGrid>
                <a:gridCol w="757910">
                  <a:extLst>
                    <a:ext uri="{9D8B030D-6E8A-4147-A177-3AD203B41FA5}">
                      <a16:colId xmlns:a16="http://schemas.microsoft.com/office/drawing/2014/main" val="573038496"/>
                    </a:ext>
                  </a:extLst>
                </a:gridCol>
                <a:gridCol w="757910">
                  <a:extLst>
                    <a:ext uri="{9D8B030D-6E8A-4147-A177-3AD203B41FA5}">
                      <a16:colId xmlns:a16="http://schemas.microsoft.com/office/drawing/2014/main" val="2967310620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953635988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034104092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531920848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4262951414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2432249493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2689284888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2916854602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1962353871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2754081605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527310350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659652546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4181166596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3476402372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469503468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438041335"/>
                    </a:ext>
                  </a:extLst>
                </a:gridCol>
                <a:gridCol w="450908">
                  <a:extLst>
                    <a:ext uri="{9D8B030D-6E8A-4147-A177-3AD203B41FA5}">
                      <a16:colId xmlns:a16="http://schemas.microsoft.com/office/drawing/2014/main" val="542578294"/>
                    </a:ext>
                  </a:extLst>
                </a:gridCol>
              </a:tblGrid>
              <a:tr h="248537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plementary table5. Association between broad ACE component and IRR of mortality (Modified Poisson regression model)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8008645"/>
                  </a:ext>
                </a:extLst>
              </a:tr>
              <a:tr h="2155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n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4700998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5058667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=5,386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296589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erpersonal loss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2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5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3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3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5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4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8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4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5085712"/>
                  </a:ext>
                </a:extLst>
              </a:tr>
              <a:tr h="42414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psychopathology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0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58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4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1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7740387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use &amp; neglect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0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8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0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8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1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0833086"/>
                  </a:ext>
                </a:extLst>
              </a:tr>
              <a:tr h="2155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omen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5648575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1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2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3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67551169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=6,348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RR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%CI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4979083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erpersonal loss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495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5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8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88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8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75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1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65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6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0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3240737"/>
                  </a:ext>
                </a:extLst>
              </a:tr>
              <a:tr h="424149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psychopathology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1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98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1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3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63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3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2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1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14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3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6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5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07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75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7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40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231517"/>
                  </a:ext>
                </a:extLst>
              </a:tr>
              <a:tr h="215526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use &amp; neglect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54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4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29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1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39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54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7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6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62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86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92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4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6</a:t>
                      </a:r>
                    </a:p>
                  </a:txBody>
                  <a:tcPr marL="5043" marR="5043" marT="50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81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983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0468466"/>
                  </a:ext>
                </a:extLst>
              </a:tr>
              <a:tr h="424149">
                <a:tc gridSpan="6"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erpersonal loss: parental loss or parental divorce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0591242"/>
                  </a:ext>
                </a:extLst>
              </a:tr>
              <a:tr h="42414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psychopathology: parental mental illness or family violence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4331428"/>
                  </a:ext>
                </a:extLst>
              </a:tr>
              <a:tr h="215526">
                <a:tc gridSpan="11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use and neglect (physical abuse, psychological neglect, or psychological abuse).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6122147"/>
                  </a:ext>
                </a:extLst>
              </a:tr>
              <a:tr h="424149">
                <a:tc gridSpan="17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te. Controlled for age, childhood economical hardship, height, education, equivalized income, longest occupation, smoing, drinking, Disease, depressive symptom, martial status, frequency of meeting friends, social participation, employment status.   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2397869"/>
                  </a:ext>
                </a:extLst>
              </a:tr>
              <a:tr h="215526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ude includes cumulative ACEs score 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2023374"/>
                  </a:ext>
                </a:extLst>
              </a:tr>
              <a:tr h="428037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1 Includes Crude Model and age and adverse childhood experiences (economic status in childhood, height, educational history) and socioeconomic status in old age (equivalized income, employment status).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4766274"/>
                  </a:ext>
                </a:extLst>
              </a:tr>
              <a:tr h="428037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2 includes Model 2 and health status in old age (hypertension, diabetes, dyslipidemia, heart disease, respiratory disease, cancer) and lifestyle (smoking and alcohol).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1995734"/>
                  </a:ext>
                </a:extLst>
              </a:tr>
              <a:tr h="428037">
                <a:tc gridSpan="18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del 3 includes Model 3 and social relationships in old age (social participation, frequency of interaction with friends, employment status, marital status). 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020241"/>
                  </a:ext>
                </a:extLst>
              </a:tr>
              <a:tr h="215526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: Adverse Childhood Experiences, IRR: Incidence Rate Ratio, CI: Confidence Interval  </a:t>
                      </a: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43" marR="5043" marT="5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01000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08521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6</Words>
  <Application>Microsoft Office PowerPoint</Application>
  <PresentationFormat>ワイド画面</PresentationFormat>
  <Paragraphs>15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巌 千嶋</dc:creator>
  <cp:lastModifiedBy>巌 千嶋</cp:lastModifiedBy>
  <cp:revision>1</cp:revision>
  <dcterms:created xsi:type="dcterms:W3CDTF">2024-11-03T05:48:53Z</dcterms:created>
  <dcterms:modified xsi:type="dcterms:W3CDTF">2024-11-03T05:49:50Z</dcterms:modified>
</cp:coreProperties>
</file>